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36576000" cy="36576000"/>
  <p:notesSz cx="6858000" cy="9144000"/>
  <p:defaultTextStyle>
    <a:defPPr>
      <a:defRPr lang="en-US"/>
    </a:defPPr>
    <a:lvl1pPr marL="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1pPr>
    <a:lvl2pPr marL="182875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2pPr>
    <a:lvl3pPr marL="3657509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3pPr>
    <a:lvl4pPr marL="5486263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4pPr>
    <a:lvl5pPr marL="7315017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5pPr>
    <a:lvl6pPr marL="9143771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6pPr>
    <a:lvl7pPr marL="10972526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7pPr>
    <a:lvl8pPr marL="1280128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8pPr>
    <a:lvl9pPr marL="1463003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Untitled Section" id="{EC65E27F-D964-45FA-A7A8-F12F7BBE60B6}">
          <p14:sldIdLst/>
        </p14:section>
        <p14:section name="Untitled Section" id="{33308B84-2333-4D92-8908-6236067885C8}">
          <p14:sldIdLst/>
        </p14:section>
        <p14:section name="Untitled Section" id="{E95C74CC-1FA4-46FA-AEF6-F49B0B0DD450}">
          <p14:sldIdLst>
            <p14:sldId id="281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9999"/>
    <a:srgbClr val="FFCCCC"/>
    <a:srgbClr val="FFFF99"/>
    <a:srgbClr val="FFFFCC"/>
    <a:srgbClr val="FFFFFF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479" autoAdjust="0"/>
    <p:restoredTop sz="96198" autoAdjust="0"/>
  </p:normalViewPr>
  <p:slideViewPr>
    <p:cSldViewPr>
      <p:cViewPr>
        <p:scale>
          <a:sx n="20" d="100"/>
          <a:sy n="20" d="100"/>
        </p:scale>
        <p:origin x="-3372" y="-696"/>
      </p:cViewPr>
      <p:guideLst>
        <p:guide orient="horz" pos="11520"/>
        <p:guide pos="1152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11F006-DB27-4641-BAE2-FEAA289E6C5B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3EC4BE-BA03-41A4-9878-8EFEEB5B9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2134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37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754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3131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7509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1886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6263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40064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501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11362280"/>
            <a:ext cx="31089600" cy="78401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86400" y="20726400"/>
            <a:ext cx="25603200" cy="9347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486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3150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1437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228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51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517600" y="1464744"/>
            <a:ext cx="8229600" cy="312081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28800" y="1464744"/>
            <a:ext cx="24079200" cy="312081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098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1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9252" y="23503480"/>
            <a:ext cx="31089600" cy="7264400"/>
          </a:xfrm>
        </p:spPr>
        <p:txBody>
          <a:bodyPr anchor="t"/>
          <a:lstStyle>
            <a:lvl1pPr algn="l">
              <a:defRPr sz="16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9252" y="15502472"/>
            <a:ext cx="31089600" cy="8001000"/>
          </a:xfrm>
        </p:spPr>
        <p:txBody>
          <a:bodyPr anchor="b"/>
          <a:lstStyle>
            <a:lvl1pPr marL="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1pPr>
            <a:lvl2pPr marL="1828754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2pPr>
            <a:lvl3pPr marL="3657509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3pPr>
            <a:lvl4pPr marL="5486263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4pPr>
            <a:lvl5pPr marL="7315017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5pPr>
            <a:lvl6pPr marL="9143771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711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28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92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358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187272"/>
            <a:ext cx="16160752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8800" y="11599336"/>
            <a:ext cx="16160752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80115" y="8187272"/>
            <a:ext cx="16167100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80115" y="11599336"/>
            <a:ext cx="16167100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04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924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934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10" y="1456264"/>
            <a:ext cx="12033252" cy="6197600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300200" y="1456282"/>
            <a:ext cx="20447000" cy="31216604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28810" y="7653882"/>
            <a:ext cx="12033252" cy="25019004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410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69152" y="25603203"/>
            <a:ext cx="21945600" cy="3022604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169152" y="3268136"/>
            <a:ext cx="21945600" cy="21945600"/>
          </a:xfrm>
        </p:spPr>
        <p:txBody>
          <a:bodyPr/>
          <a:lstStyle>
            <a:lvl1pPr marL="0" indent="0">
              <a:buNone/>
              <a:defRPr sz="12800"/>
            </a:lvl1pPr>
            <a:lvl2pPr marL="1828754" indent="0">
              <a:buNone/>
              <a:defRPr sz="11200"/>
            </a:lvl2pPr>
            <a:lvl3pPr marL="3657509" indent="0">
              <a:buNone/>
              <a:defRPr sz="9600"/>
            </a:lvl3pPr>
            <a:lvl4pPr marL="5486263" indent="0">
              <a:buNone/>
              <a:defRPr sz="8000"/>
            </a:lvl4pPr>
            <a:lvl5pPr marL="7315017" indent="0">
              <a:buNone/>
              <a:defRPr sz="8000"/>
            </a:lvl5pPr>
            <a:lvl6pPr marL="9143771" indent="0">
              <a:buNone/>
              <a:defRPr sz="8000"/>
            </a:lvl6pPr>
            <a:lvl7pPr marL="10972526" indent="0">
              <a:buNone/>
              <a:defRPr sz="8000"/>
            </a:lvl7pPr>
            <a:lvl8pPr marL="12801280" indent="0">
              <a:buNone/>
              <a:defRPr sz="8000"/>
            </a:lvl8pPr>
            <a:lvl9pPr marL="14630034" indent="0">
              <a:buNone/>
              <a:defRPr sz="8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69152" y="28625804"/>
            <a:ext cx="21945600" cy="4292600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028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28800" y="1464736"/>
            <a:ext cx="32918400" cy="6096000"/>
          </a:xfrm>
          <a:prstGeom prst="rect">
            <a:avLst/>
          </a:prstGeom>
        </p:spPr>
        <p:txBody>
          <a:bodyPr vert="horz" lIns="365751" tIns="182875" rIns="365751" bIns="18287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534412"/>
            <a:ext cx="32918400" cy="24138472"/>
          </a:xfrm>
          <a:prstGeom prst="rect">
            <a:avLst/>
          </a:prstGeom>
        </p:spPr>
        <p:txBody>
          <a:bodyPr vert="horz" lIns="365751" tIns="182875" rIns="365751" bIns="18287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28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496800" y="33900548"/>
            <a:ext cx="11582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212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723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57509" rtl="0" eaLnBrk="1" latinLnBrk="0" hangingPunct="1"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566" indent="-1371566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1pPr>
      <a:lvl2pPr marL="2971726" indent="-1142971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11200" kern="1200">
          <a:solidFill>
            <a:schemeClr val="tx1"/>
          </a:solidFill>
          <a:latin typeface="+mn-lt"/>
          <a:ea typeface="+mn-ea"/>
          <a:cs typeface="+mn-cs"/>
        </a:defRPr>
      </a:lvl2pPr>
      <a:lvl3pPr marL="4571886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640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80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394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»"/>
        <a:defRPr sz="80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149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6903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5657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411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75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509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263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017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3771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526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28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03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/>
          <a:srcRect r="23729"/>
          <a:stretch/>
        </p:blipFill>
        <p:spPr bwMode="auto">
          <a:xfrm>
            <a:off x="1237933" y="18407634"/>
            <a:ext cx="16496137" cy="173301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5"/>
          <p:cNvPicPr/>
          <p:nvPr/>
        </p:nvPicPr>
        <p:blipFill rotWithShape="1">
          <a:blip r:embed="rId3" cstate="print"/>
          <a:srcRect r="24678"/>
          <a:stretch/>
        </p:blipFill>
        <p:spPr bwMode="auto">
          <a:xfrm>
            <a:off x="17578136" y="18399336"/>
            <a:ext cx="16254663" cy="17290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6"/>
          <p:cNvPicPr/>
          <p:nvPr/>
        </p:nvPicPr>
        <p:blipFill rotWithShape="1">
          <a:blip r:embed="rId4" cstate="print"/>
          <a:srcRect t="15814" r="23629"/>
          <a:stretch/>
        </p:blipFill>
        <p:spPr bwMode="auto">
          <a:xfrm>
            <a:off x="17602402" y="6710519"/>
            <a:ext cx="16535198" cy="147087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7"/>
          <p:cNvPicPr/>
          <p:nvPr/>
        </p:nvPicPr>
        <p:blipFill rotWithShape="1">
          <a:blip r:embed="rId5" cstate="print"/>
          <a:srcRect t="4415" r="24461"/>
          <a:stretch/>
        </p:blipFill>
        <p:spPr bwMode="auto">
          <a:xfrm>
            <a:off x="1219200" y="6710520"/>
            <a:ext cx="16377783" cy="144044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13915979" y="22042461"/>
            <a:ext cx="316625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4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  <a:endParaRPr 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0251400" y="22019933"/>
            <a:ext cx="316625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4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  <a:endParaRPr 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0219868" y="7687082"/>
            <a:ext cx="316625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4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  <a:endParaRPr 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3852916" y="7692190"/>
            <a:ext cx="316625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4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  <a:endParaRPr 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477000" y="4702076"/>
            <a:ext cx="8238153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bnormalities 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d by 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Pseq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1869380" y="4702076"/>
            <a:ext cx="9982220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bnormalities identified </a:t>
            </a:r>
          </a:p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y chromosome studie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37259" y="1618657"/>
            <a:ext cx="33695741" cy="2585313"/>
          </a:xfrm>
          <a:prstGeom prst="rect">
            <a:avLst/>
          </a:prstGeom>
          <a:noFill/>
        </p:spPr>
        <p:txBody>
          <a:bodyPr wrap="square" lIns="365751" tIns="182875" rIns="365751" bIns="182875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6: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verall survival between presence or absence of genomic complexity identified by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MPseq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or chromosome studies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965830" y="26974800"/>
            <a:ext cx="4898264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 err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romoplexy</a:t>
            </a:r>
            <a:r>
              <a:rPr lang="en-US" sz="4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No</a:t>
            </a:r>
          </a:p>
          <a:p>
            <a:r>
              <a:rPr lang="en-US" sz="4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48</a:t>
            </a:r>
            <a:endParaRPr lang="en-US" sz="48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925405" y="31927800"/>
            <a:ext cx="5104795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 err="1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romoplexy</a:t>
            </a:r>
            <a:r>
              <a:rPr lang="en-US" sz="4800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Yes</a:t>
            </a:r>
          </a:p>
          <a:p>
            <a:r>
              <a:rPr lang="en-US" sz="4800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3</a:t>
            </a:r>
            <a:endParaRPr lang="en-US" sz="4800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4509605" y="26974800"/>
            <a:ext cx="744626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 err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nosomal</a:t>
            </a:r>
            <a:r>
              <a:rPr lang="en-US" sz="4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Karyotype, No</a:t>
            </a:r>
          </a:p>
          <a:p>
            <a:r>
              <a:rPr lang="en-US" sz="4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58</a:t>
            </a:r>
            <a:endParaRPr lang="en-US" sz="48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4534066" y="31926059"/>
            <a:ext cx="7652801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 err="1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nosomal</a:t>
            </a:r>
            <a:r>
              <a:rPr lang="en-US" sz="48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Karyotype</a:t>
            </a:r>
            <a:r>
              <a:rPr lang="en-US" sz="4800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Yes</a:t>
            </a:r>
          </a:p>
          <a:p>
            <a:r>
              <a:rPr lang="en-US" sz="4800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32</a:t>
            </a:r>
            <a:endParaRPr lang="en-US" sz="4800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7946780" y="11582400"/>
            <a:ext cx="7535204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 err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romothripsis</a:t>
            </a:r>
            <a:r>
              <a:rPr lang="en-US" sz="4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endParaRPr lang="en-US" sz="48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4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gressive complexity, No</a:t>
            </a:r>
          </a:p>
          <a:p>
            <a:r>
              <a:rPr lang="en-US" sz="4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45</a:t>
            </a:r>
            <a:endParaRPr lang="en-US" sz="48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7946962" y="16840200"/>
            <a:ext cx="7741735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 err="1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romothripsis</a:t>
            </a:r>
            <a:r>
              <a:rPr lang="en-US" sz="4800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endParaRPr lang="en-US" sz="4800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4800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gressive complexity, Yes</a:t>
            </a:r>
          </a:p>
          <a:p>
            <a:r>
              <a:rPr lang="en-US" sz="4800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6</a:t>
            </a:r>
            <a:endParaRPr lang="en-US" sz="4800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3906748" y="16925928"/>
            <a:ext cx="958627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3 chromosome abnormalities, </a:t>
            </a:r>
            <a:r>
              <a:rPr lang="en-US" sz="4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  <a:p>
            <a:r>
              <a:rPr lang="en-US" sz="4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    N=32</a:t>
            </a:r>
            <a:endParaRPr lang="en-US" sz="48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3878204" y="11951732"/>
            <a:ext cx="979280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3 chromosome abnormalities, Yes</a:t>
            </a:r>
          </a:p>
          <a:p>
            <a:r>
              <a:rPr lang="en-US" sz="4800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58</a:t>
            </a:r>
            <a:endParaRPr lang="en-US" sz="4800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290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73</TotalTime>
  <Words>79</Words>
  <Application>Microsoft Office PowerPoint</Application>
  <PresentationFormat>Custom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a Baughn</dc:creator>
  <cp:lastModifiedBy>Baughn, Linda B., Ph.D.</cp:lastModifiedBy>
  <cp:revision>317</cp:revision>
  <dcterms:created xsi:type="dcterms:W3CDTF">2019-10-01T15:18:01Z</dcterms:created>
  <dcterms:modified xsi:type="dcterms:W3CDTF">2020-12-30T23:38:44Z</dcterms:modified>
</cp:coreProperties>
</file>